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9" r:id="rId2"/>
  </p:sldIdLst>
  <p:sldSz cx="7772400" cy="100584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3083" autoAdjust="0"/>
    <p:restoredTop sz="94660"/>
  </p:normalViewPr>
  <p:slideViewPr>
    <p:cSldViewPr snapToGrid="0">
      <p:cViewPr varScale="1">
        <p:scale>
          <a:sx n="96" d="100"/>
          <a:sy n="96" d="100"/>
        </p:scale>
        <p:origin x="3168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75" d="100"/>
        <a:sy n="75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86BA7-E5B2-4201-8E35-CF2356FEF49C}" type="datetimeFigureOut">
              <a:rPr lang="en-US" smtClean="0"/>
              <a:t>3/14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8CE6D7-E11B-4538-BC13-A2282ACE8B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28569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86BA7-E5B2-4201-8E35-CF2356FEF49C}" type="datetimeFigureOut">
              <a:rPr lang="en-US" smtClean="0"/>
              <a:t>3/14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8CE6D7-E11B-4538-BC13-A2282ACE8B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99298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86BA7-E5B2-4201-8E35-CF2356FEF49C}" type="datetimeFigureOut">
              <a:rPr lang="en-US" smtClean="0"/>
              <a:t>3/14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8CE6D7-E11B-4538-BC13-A2282ACE8B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91454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86BA7-E5B2-4201-8E35-CF2356FEF49C}" type="datetimeFigureOut">
              <a:rPr lang="en-US" smtClean="0"/>
              <a:t>3/14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8CE6D7-E11B-4538-BC13-A2282ACE8B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70707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86BA7-E5B2-4201-8E35-CF2356FEF49C}" type="datetimeFigureOut">
              <a:rPr lang="en-US" smtClean="0"/>
              <a:t>3/14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8CE6D7-E11B-4538-BC13-A2282ACE8B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63095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86BA7-E5B2-4201-8E35-CF2356FEF49C}" type="datetimeFigureOut">
              <a:rPr lang="en-US" smtClean="0"/>
              <a:t>3/14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8CE6D7-E11B-4538-BC13-A2282ACE8B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49067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86BA7-E5B2-4201-8E35-CF2356FEF49C}" type="datetimeFigureOut">
              <a:rPr lang="en-US" smtClean="0"/>
              <a:t>3/14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8CE6D7-E11B-4538-BC13-A2282ACE8B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7055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86BA7-E5B2-4201-8E35-CF2356FEF49C}" type="datetimeFigureOut">
              <a:rPr lang="en-US" smtClean="0"/>
              <a:t>3/14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8CE6D7-E11B-4538-BC13-A2282ACE8B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76468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86BA7-E5B2-4201-8E35-CF2356FEF49C}" type="datetimeFigureOut">
              <a:rPr lang="en-US" smtClean="0"/>
              <a:t>3/14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8CE6D7-E11B-4538-BC13-A2282ACE8B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60775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86BA7-E5B2-4201-8E35-CF2356FEF49C}" type="datetimeFigureOut">
              <a:rPr lang="en-US" smtClean="0"/>
              <a:t>3/14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8CE6D7-E11B-4538-BC13-A2282ACE8B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85679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86BA7-E5B2-4201-8E35-CF2356FEF49C}" type="datetimeFigureOut">
              <a:rPr lang="en-US" smtClean="0"/>
              <a:t>3/14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8CE6D7-E11B-4538-BC13-A2282ACE8B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41276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086BA7-E5B2-4201-8E35-CF2356FEF49C}" type="datetimeFigureOut">
              <a:rPr lang="en-US" smtClean="0"/>
              <a:t>3/14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8CE6D7-E11B-4538-BC13-A2282ACE8B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30717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69254283"/>
              </p:ext>
            </p:extLst>
          </p:nvPr>
        </p:nvGraphicFramePr>
        <p:xfrm>
          <a:off x="384176" y="69851"/>
          <a:ext cx="7029452" cy="9514291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2492374"/>
                <a:gridCol w="628650"/>
                <a:gridCol w="342900"/>
                <a:gridCol w="314325"/>
                <a:gridCol w="762000"/>
                <a:gridCol w="428625"/>
                <a:gridCol w="190500"/>
                <a:gridCol w="85725"/>
                <a:gridCol w="466725"/>
                <a:gridCol w="666750"/>
                <a:gridCol w="650878"/>
              </a:tblGrid>
              <a:tr h="363287">
                <a:tc gridSpan="11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en-US" sz="10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ble S1. Statistical Testing</a:t>
                      </a:r>
                      <a:endParaRPr lang="en-US" sz="10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00584" marR="10058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00584" marR="10058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00584" marR="10058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0">
                <a:tc gridSpan="11"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/>
                    </a:solidFill>
                  </a:tcPr>
                </a:tc>
                <a:tc hMerge="1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00584" marR="10058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00584" marR="10058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00584" marR="10058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351112">
                <a:tc gridSpan="11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</a:pPr>
                      <a:r>
                        <a:rPr lang="en-US" sz="9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rmality Metrics &amp; Normality Hypothesis Testing</a:t>
                      </a:r>
                      <a:endParaRPr lang="en-US" sz="9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00584" marR="10058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00584" marR="10058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00584" marR="10058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4639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3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rmality Metrics</a:t>
                      </a:r>
                      <a:r>
                        <a:rPr lang="en-US" sz="900" b="1" baseline="300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800" b="1" baseline="300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7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rmality Hypothesis Testing</a:t>
                      </a:r>
                      <a:r>
                        <a:rPr lang="en-US" sz="800" b="1" baseline="300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US" sz="800" b="1" baseline="300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b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00584" marR="10058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b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00584" marR="10058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361266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</a:pP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kewness</a:t>
                      </a:r>
                      <a:endParaRPr lang="en-US" sz="800" b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urtosis</a:t>
                      </a:r>
                      <a:endParaRPr lang="en-US" sz="800" b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hapiro-Wilk</a:t>
                      </a:r>
                      <a:endParaRPr lang="en-US" sz="800" b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hapiro-</a:t>
                      </a:r>
                      <a:r>
                        <a:rPr lang="en-US" sz="800" b="1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rancia</a:t>
                      </a:r>
                      <a:endParaRPr lang="en-US" sz="800" b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illiefors</a:t>
                      </a:r>
                      <a:endParaRPr lang="en-US" sz="800" b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b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derson-Darling</a:t>
                      </a:r>
                      <a:endParaRPr lang="en-US" sz="800" b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ramer-von Mises</a:t>
                      </a:r>
                      <a:endParaRPr lang="en-US" sz="800" b="1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32433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e-Test </a:t>
                      </a:r>
                      <a:r>
                        <a:rPr lang="en-US" sz="8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iber Diameter</a:t>
                      </a: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r>
                        <a:rPr lang="en-US" sz="8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09</a:t>
                      </a: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tc grid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187</a:t>
                      </a: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0.001</a:t>
                      </a: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tc grid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0.001</a:t>
                      </a: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0.001</a:t>
                      </a: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0.001</a:t>
                      </a: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0.001</a:t>
                      </a: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</a:tr>
              <a:tr h="232433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st-Test Fiber </a:t>
                      </a: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iameter</a:t>
                      </a: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0.001</a:t>
                      </a: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r>
                        <a:rPr lang="en-US" sz="8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486</a:t>
                      </a: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47</a:t>
                      </a: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tc grid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07</a:t>
                      </a: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77</a:t>
                      </a:r>
                      <a:endParaRPr lang="en-US" sz="8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48</a:t>
                      </a: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60</a:t>
                      </a: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32433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Pre-Test Fiber Diameter Percent Error</a:t>
                      </a: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.339</a:t>
                      </a: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tc grid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0.024</a:t>
                      </a: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&lt;0.001</a:t>
                      </a: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tc grid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&lt;0.001</a:t>
                      </a: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&lt;0.001</a:t>
                      </a: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&lt;0.001</a:t>
                      </a: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&lt;0.001</a:t>
                      </a: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</a:tr>
              <a:tr h="232433">
                <a:tc>
                  <a:txBody>
                    <a:bodyPr/>
                    <a:lstStyle/>
                    <a:p>
                      <a:pPr marL="0" marR="0" indent="0" algn="r" defTabSz="77724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Pre-Test Fiber Diameter Percent Error</a:t>
                      </a: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759</a:t>
                      </a: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1.144</a:t>
                      </a: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&lt;0.001</a:t>
                      </a: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tc grid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.001</a:t>
                      </a: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&lt;0.001</a:t>
                      </a: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&lt;0.001</a:t>
                      </a: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&lt;0.001</a:t>
                      </a: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</a:tr>
              <a:tr h="232433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e-Test Pore Area</a:t>
                      </a: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66</a:t>
                      </a: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360</a:t>
                      </a: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78</a:t>
                      </a: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12</a:t>
                      </a: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50</a:t>
                      </a: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42</a:t>
                      </a: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52</a:t>
                      </a: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32433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st-Test Pore Area</a:t>
                      </a: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521</a:t>
                      </a:r>
                      <a:endParaRPr lang="en-US" sz="8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647</a:t>
                      </a: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22</a:t>
                      </a: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33</a:t>
                      </a: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00</a:t>
                      </a:r>
                      <a:endParaRPr lang="en-US" sz="8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90</a:t>
                      </a: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59</a:t>
                      </a: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32433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e-Test </a:t>
                      </a: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rosity</a:t>
                      </a: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250</a:t>
                      </a: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tc grid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33</a:t>
                      </a:r>
                      <a:endParaRPr lang="en-US" sz="8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26</a:t>
                      </a: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tc grid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21</a:t>
                      </a: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97</a:t>
                      </a: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72</a:t>
                      </a: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50</a:t>
                      </a:r>
                      <a:endParaRPr lang="en-US" sz="8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32433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st-Test </a:t>
                      </a: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rosity</a:t>
                      </a: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158</a:t>
                      </a:r>
                      <a:endParaRPr lang="en-US" sz="8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140</a:t>
                      </a: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42</a:t>
                      </a:r>
                      <a:endParaRPr lang="en-US" sz="8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84</a:t>
                      </a: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21</a:t>
                      </a: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23</a:t>
                      </a: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34</a:t>
                      </a: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32433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e-Test Intersection Density</a:t>
                      </a: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860</a:t>
                      </a: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tc grid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080</a:t>
                      </a: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0.001</a:t>
                      </a: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tc grid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0.001</a:t>
                      </a: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0.001</a:t>
                      </a: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0.001</a:t>
                      </a: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0.001</a:t>
                      </a: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</a:tr>
              <a:tr h="232433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st-Test Intersection Density</a:t>
                      </a: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67</a:t>
                      </a: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580</a:t>
                      </a: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7</a:t>
                      </a: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tc grid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19</a:t>
                      </a: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65</a:t>
                      </a: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8</a:t>
                      </a: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11</a:t>
                      </a: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</a:tr>
              <a:tr h="232433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e-Test </a:t>
                      </a:r>
                      <a:r>
                        <a:rPr lang="en-US" sz="8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Length between Intersections</a:t>
                      </a: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600</a:t>
                      </a: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tc grid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60</a:t>
                      </a: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0.001</a:t>
                      </a: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tc grid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1</a:t>
                      </a: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0.001</a:t>
                      </a: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0.001</a:t>
                      </a: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0.001</a:t>
                      </a: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</a:tr>
              <a:tr h="232433">
                <a:tc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st-Test Length between Intersections</a:t>
                      </a: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0.950</a:t>
                      </a: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11</a:t>
                      </a:r>
                      <a:endParaRPr lang="en-US" sz="8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68</a:t>
                      </a: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50</a:t>
                      </a: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79</a:t>
                      </a: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28</a:t>
                      </a: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32</a:t>
                      </a: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88883">
                <a:tc gridSpan="11">
                  <a:txBody>
                    <a:bodyPr/>
                    <a:lstStyle/>
                    <a:p>
                      <a:r>
                        <a:rPr lang="en-US" sz="800" b="0" i="1" baseline="300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1</a:t>
                      </a:r>
                      <a:r>
                        <a:rPr lang="en-US" sz="800" b="0" i="1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Values are normality metrics,</a:t>
                      </a:r>
                      <a:r>
                        <a:rPr lang="en-US" sz="800" b="0" i="1" kern="1200" baseline="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sk</a:t>
                      </a:r>
                      <a:r>
                        <a:rPr lang="en-US" sz="800" b="0" i="1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ewness and grey shading indicates values great than 1 or less than -1, which suggests non-normality. </a:t>
                      </a:r>
                    </a:p>
                    <a:p>
                      <a:r>
                        <a:rPr lang="en-US" sz="800" b="0" i="1" kern="1200" baseline="300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2</a:t>
                      </a:r>
                      <a:r>
                        <a:rPr lang="en-US" sz="800" b="0" i="1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P-values are shown and</a:t>
                      </a:r>
                      <a:r>
                        <a:rPr lang="en-US" sz="800" b="0" i="1" kern="1200" baseline="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gray shading indicates non-normality (P &lt; 0.05).</a:t>
                      </a:r>
                      <a:r>
                        <a:rPr lang="en-US" sz="800" b="0" i="1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800" b="0" i="1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 </a:t>
                      </a:r>
                      <a:endParaRPr lang="en-US" sz="800" b="0" i="1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0">
                <a:tc gridSpan="11">
                  <a:txBody>
                    <a:bodyPr/>
                    <a:lstStyle/>
                    <a:p>
                      <a:pPr marL="0" marR="0" algn="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/>
                    </a:solidFill>
                  </a:tcPr>
                </a:tc>
                <a:tc hMerge="1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00584" marR="10058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00584" marR="10058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00584" marR="10058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342487">
                <a:tc gridSpan="11">
                  <a:txBody>
                    <a:bodyPr/>
                    <a:lstStyle/>
                    <a:p>
                      <a:pPr marL="0" marR="0" indent="0" algn="ctr" defTabSz="77724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ypothesis Testing: Variances </a:t>
                      </a: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00584" marR="10058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00584" marR="10058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00584" marR="10058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33838">
                <a:tc gridSpan="3">
                  <a:txBody>
                    <a:bodyPr/>
                    <a:lstStyle/>
                    <a:p>
                      <a:pPr algn="r"/>
                      <a:r>
                        <a:rPr lang="en-US" sz="8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iber Metric     </a:t>
                      </a:r>
                      <a:endParaRPr lang="en-US" sz="8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800" b="1" dirty="0" smtClean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atistical Test</a:t>
                      </a: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5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e-Test vs Post-Test</a:t>
                      </a:r>
                      <a:r>
                        <a:rPr lang="en-US" sz="800" b="1" baseline="300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00584" marR="10058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00584" marR="10058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22348">
                <a:tc gridSpan="3">
                  <a:txBody>
                    <a:bodyPr/>
                    <a:lstStyle/>
                    <a:p>
                      <a:pPr algn="r"/>
                      <a:r>
                        <a:rPr lang="en-US" sz="8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iber Diameter (25.6 µm &amp; 31.1 µm Pooled Variances) </a:t>
                      </a:r>
                      <a:endParaRPr lang="en-US" sz="8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 err="1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evene’s</a:t>
                      </a:r>
                      <a:r>
                        <a:rPr lang="en-US" sz="8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Test</a:t>
                      </a:r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5"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296</a:t>
                      </a:r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00584" marR="10058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00584" marR="10058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33838">
                <a:tc gridSpan="3">
                  <a:txBody>
                    <a:bodyPr/>
                    <a:lstStyle/>
                    <a:p>
                      <a:pPr algn="r"/>
                      <a:r>
                        <a:rPr lang="en-US" sz="8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re Area   </a:t>
                      </a:r>
                      <a:endParaRPr lang="en-US" sz="8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800" dirty="0" smtClean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 err="1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evene’s</a:t>
                      </a:r>
                      <a:r>
                        <a:rPr lang="en-US" sz="8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Test</a:t>
                      </a: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5"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09</a:t>
                      </a:r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00584" marR="10058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00584" marR="10058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33838">
                <a:tc gridSpan="3">
                  <a:txBody>
                    <a:bodyPr/>
                    <a:lstStyle/>
                    <a:p>
                      <a:pPr algn="r"/>
                      <a:r>
                        <a:rPr lang="en-US" sz="8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rosity </a:t>
                      </a:r>
                      <a:endParaRPr lang="en-US" sz="8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800" dirty="0" smtClean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 err="1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evene’s</a:t>
                      </a:r>
                      <a:r>
                        <a:rPr lang="en-US" sz="8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Test</a:t>
                      </a: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5"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106</a:t>
                      </a:r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00584" marR="10058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00584" marR="10058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33838">
                <a:tc gridSpan="3">
                  <a:txBody>
                    <a:bodyPr/>
                    <a:lstStyle/>
                    <a:p>
                      <a:pPr algn="r"/>
                      <a:r>
                        <a:rPr lang="en-US" sz="8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tersection Density</a:t>
                      </a:r>
                      <a:endParaRPr lang="en-US" sz="8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800" dirty="0" smtClean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linger-Killeen’s Test</a:t>
                      </a: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5"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94</a:t>
                      </a:r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00584" marR="10058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00584" marR="10058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33838">
                <a:tc gridSpan="3">
                  <a:txBody>
                    <a:bodyPr/>
                    <a:lstStyle/>
                    <a:p>
                      <a:pPr algn="r"/>
                      <a:r>
                        <a:rPr lang="en-US" sz="8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ength Between Intersections</a:t>
                      </a:r>
                      <a:endParaRPr lang="en-US" sz="8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800" dirty="0" smtClean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linger-Killeen’s Test</a:t>
                      </a: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5"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133</a:t>
                      </a:r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00584" marR="10058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00584" marR="10058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0">
                <a:tc gridSpan="11">
                  <a:txBody>
                    <a:bodyPr/>
                    <a:lstStyle/>
                    <a:p>
                      <a:pPr marL="0" marR="0" indent="0" algn="l" defTabSz="77724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1" i="1" u="none" baseline="300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3</a:t>
                      </a:r>
                      <a:r>
                        <a:rPr lang="en-US" sz="800" b="0" i="1" u="none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 values are shown &amp; grey shading indicates significant differences</a:t>
                      </a:r>
                      <a:r>
                        <a:rPr lang="en-US" sz="800" b="0" i="1" u="none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P &lt; 0.05).</a:t>
                      </a:r>
                      <a:endParaRPr lang="en-US" sz="800" b="0" i="1" u="none" dirty="0" smtClean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800" dirty="0" smtClean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84029">
                <a:tc gridSpan="11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tx1"/>
                    </a:solidFill>
                  </a:tcPr>
                </a:tc>
                <a:tc hMerge="1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00584" marR="10058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00584" marR="10058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00584" marR="10058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373730">
                <a:tc gridSpan="11">
                  <a:txBody>
                    <a:bodyPr/>
                    <a:lstStyle/>
                    <a:p>
                      <a:pPr marL="0" marR="0" indent="0" algn="ctr" defTabSz="77724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ypothesis Testing: Means or Medians</a:t>
                      </a:r>
                      <a:r>
                        <a:rPr lang="en-US" sz="900" b="1" baseline="300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en-US" sz="900" dirty="0" smtClean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00584" marR="10058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00584" marR="10058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00584" marR="10058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33838">
                <a:tc gridSpan="2">
                  <a:txBody>
                    <a:bodyPr/>
                    <a:lstStyle/>
                    <a:p>
                      <a:pPr algn="r"/>
                      <a:r>
                        <a:rPr lang="en-US" sz="8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iber Metric</a:t>
                      </a:r>
                      <a:endParaRPr lang="en-US" sz="8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800" b="1" dirty="0" smtClean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6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atistical Test</a:t>
                      </a: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e-Test vs Post-Test*</a:t>
                      </a: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00584" marR="10058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33838">
                <a:tc gridSpan="2">
                  <a:txBody>
                    <a:bodyPr/>
                    <a:lstStyle/>
                    <a:p>
                      <a:pPr algn="r"/>
                      <a:r>
                        <a:rPr lang="en-US" sz="8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iber Diameter Bimodal</a:t>
                      </a:r>
                      <a:endParaRPr lang="en-US" sz="8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800" dirty="0" smtClean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6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isher’s Exact Test (2</a:t>
                      </a:r>
                      <a:r>
                        <a:rPr lang="en-US" sz="80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Proportions </a:t>
                      </a:r>
                      <a:r>
                        <a:rPr lang="en-US" sz="8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 0.001</a:t>
                      </a:r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00584" marR="10058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33838">
                <a:tc gridSpan="2">
                  <a:txBody>
                    <a:bodyPr/>
                    <a:lstStyle/>
                    <a:p>
                      <a:pPr algn="r"/>
                      <a:r>
                        <a:rPr lang="en-US" sz="8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iber Dia. (25.6 µm)</a:t>
                      </a:r>
                      <a:endParaRPr lang="en-US" sz="8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6"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-Sample</a:t>
                      </a:r>
                      <a:r>
                        <a:rPr lang="en-US" sz="80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8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nn-Whitney</a:t>
                      </a:r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470</a:t>
                      </a:r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00584" marR="10058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33838">
                <a:tc gridSpan="2">
                  <a:txBody>
                    <a:bodyPr/>
                    <a:lstStyle/>
                    <a:p>
                      <a:pPr algn="r"/>
                      <a:r>
                        <a:rPr lang="en-US" sz="8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iber Dia. (31.1 µm)</a:t>
                      </a:r>
                      <a:endParaRPr lang="en-US" sz="8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800" dirty="0" smtClean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6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-Sample</a:t>
                      </a:r>
                      <a:r>
                        <a:rPr lang="en-US" sz="80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8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nn-Whitney</a:t>
                      </a: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751</a:t>
                      </a:r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00584" marR="10058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33838">
                <a:tc gridSpan="2">
                  <a:txBody>
                    <a:bodyPr/>
                    <a:lstStyle/>
                    <a:p>
                      <a:pPr algn="r"/>
                      <a:r>
                        <a:rPr lang="en-US" sz="8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iber Dia. Percent Error (25.6</a:t>
                      </a:r>
                      <a:r>
                        <a:rPr lang="en-US" sz="800" b="1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8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µm </a:t>
                      </a:r>
                      <a:r>
                        <a:rPr lang="en-US" sz="800" b="1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amp; 31.1 </a:t>
                      </a:r>
                      <a:r>
                        <a:rPr lang="en-US" sz="8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µm </a:t>
                      </a:r>
                      <a:r>
                        <a:rPr lang="en-US" sz="800" b="1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oled Errors) </a:t>
                      </a:r>
                      <a:endParaRPr lang="en-US" sz="8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6"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-Way Analysis of Variance (ANOVA)</a:t>
                      </a:r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 0.001</a:t>
                      </a:r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233838">
                <a:tc gridSpan="2">
                  <a:txBody>
                    <a:bodyPr/>
                    <a:lstStyle/>
                    <a:p>
                      <a:pPr algn="r"/>
                      <a:r>
                        <a:rPr lang="en-US" sz="8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re Area</a:t>
                      </a:r>
                      <a:endParaRPr lang="en-US" sz="8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800" dirty="0" smtClean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6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ilcoxon Signed</a:t>
                      </a:r>
                      <a:r>
                        <a:rPr lang="en-US" sz="80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Rank</a:t>
                      </a:r>
                      <a:endParaRPr lang="en-US" sz="800" dirty="0" smtClean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316</a:t>
                      </a:r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00584" marR="10058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33838">
                <a:tc gridSpan="2">
                  <a:txBody>
                    <a:bodyPr/>
                    <a:lstStyle/>
                    <a:p>
                      <a:pPr algn="r"/>
                      <a:r>
                        <a:rPr lang="en-US" sz="8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rosity</a:t>
                      </a:r>
                      <a:endParaRPr lang="en-US" sz="8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6"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ilcoxon Signed</a:t>
                      </a:r>
                      <a:r>
                        <a:rPr lang="en-US" sz="80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Rank</a:t>
                      </a:r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186</a:t>
                      </a:r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00584" marR="10058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33838">
                <a:tc gridSpan="2">
                  <a:txBody>
                    <a:bodyPr/>
                    <a:lstStyle/>
                    <a:p>
                      <a:pPr algn="r"/>
                      <a:r>
                        <a:rPr lang="en-US" sz="8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tersection Density</a:t>
                      </a:r>
                      <a:endParaRPr lang="en-US" sz="8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800" dirty="0" smtClean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6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ilcoxon Signed</a:t>
                      </a:r>
                      <a:r>
                        <a:rPr lang="en-US" sz="80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Rank</a:t>
                      </a:r>
                      <a:endParaRPr lang="en-US" sz="800" dirty="0" smtClean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420</a:t>
                      </a:r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00584" marR="10058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33838">
                <a:tc gridSpan="2">
                  <a:txBody>
                    <a:bodyPr/>
                    <a:lstStyle/>
                    <a:p>
                      <a:pPr algn="r"/>
                      <a:r>
                        <a:rPr lang="en-US" sz="800" b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ength Between Intersections</a:t>
                      </a:r>
                      <a:endParaRPr lang="en-US" sz="800" b="1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800" dirty="0" smtClean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6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ilcoxon Signed</a:t>
                      </a:r>
                      <a:r>
                        <a:rPr lang="en-US" sz="800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Rank</a:t>
                      </a:r>
                      <a:endParaRPr lang="en-US" sz="800" dirty="0" smtClean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186</a:t>
                      </a:r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00584" marR="100584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33838">
                <a:tc gridSpan="11">
                  <a:txBody>
                    <a:bodyPr/>
                    <a:lstStyle/>
                    <a:p>
                      <a:pPr marL="0" marR="0" indent="0" algn="l" defTabSz="77724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1" baseline="300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4</a:t>
                      </a:r>
                      <a:r>
                        <a:rPr lang="en-US" sz="800" b="0" i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 values are shown.</a:t>
                      </a:r>
                      <a:r>
                        <a:rPr lang="en-US" sz="800" b="0" i="1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G</a:t>
                      </a:r>
                      <a:r>
                        <a:rPr lang="en-US" sz="800" b="0" i="1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y shading indicates significant differences</a:t>
                      </a:r>
                      <a:r>
                        <a:rPr lang="en-US" sz="800" b="0" i="1" baseline="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P &lt; 0.05).</a:t>
                      </a:r>
                      <a:endParaRPr lang="en-US" sz="800" b="0" i="1" dirty="0" smtClean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36576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800" dirty="0" smtClean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/>
                      <a:endParaRPr 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69520857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258</TotalTime>
  <Words>393</Words>
  <Application>Microsoft Office PowerPoint</Application>
  <PresentationFormat>Custom</PresentationFormat>
  <Paragraphs>15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NIST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imon Jr, Carl</dc:creator>
  <cp:lastModifiedBy>Nathan Hotaling</cp:lastModifiedBy>
  <cp:revision>82</cp:revision>
  <dcterms:created xsi:type="dcterms:W3CDTF">2016-02-23T18:29:33Z</dcterms:created>
  <dcterms:modified xsi:type="dcterms:W3CDTF">2016-03-14T19:51:23Z</dcterms:modified>
</cp:coreProperties>
</file>